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1" autoAdjust="0"/>
    <p:restoredTop sz="94660"/>
  </p:normalViewPr>
  <p:slideViewPr>
    <p:cSldViewPr snapToGrid="0">
      <p:cViewPr varScale="1">
        <p:scale>
          <a:sx n="83" d="100"/>
          <a:sy n="83" d="100"/>
        </p:scale>
        <p:origin x="72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B285106-8A57-C1FB-8B3E-C280D1BE88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218A1FA-2212-C2F5-A845-8A9EEE6774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0F7BA07-309A-71D3-78C6-4861E932A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5559874-4DE4-3E98-5469-2EBF14CAA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779DE6F-2426-11A8-BA31-6E3209102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348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8C05A57-495B-6384-114C-257A9AC9E6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B5E8A1B-BEA9-19AB-0AFA-3DDBF09B48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062927-0D94-DC8B-618A-7C2C244F2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E06426E-BDF4-1C32-A8D4-10A961116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878C314-86E5-5711-86B8-246CC22FE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7385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9F0F57C-8F4B-6B38-1545-32B030A581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81D9A59-DF95-6DC9-F400-F4D04A6684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A03DE21-8137-BC07-813B-8D9DCCFDB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0451D9C-9A95-9281-17AB-A281082CF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D0C97CB-0E82-EEDE-E201-316ADA45B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773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27658DB-24D8-A79F-0139-7D854D5DFA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3693789-BAD4-B51E-C54D-CE75EDAC92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3D9C0E8-7B44-6B05-4A9D-AD7978F4B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38AA7A9-424D-9964-B33E-EDE3528FC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2526A34-C03B-4C26-5B83-11BE297F1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2171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8077EF-184C-F58F-6D0C-B84406CB86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51720E0-68AA-0D4D-3B43-8210879629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7136C0-618D-B864-8B23-1BB7BE4DF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92B87B7-8E20-AF75-2592-6165CAFE0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605E57A-BB63-B7CB-0DF0-6DF06F9A6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7569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077653-DC41-6AB9-3CB9-7CF62B41E9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70BE780-7FF9-CFE9-ECBD-D56EBB9102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CCD35F5-87F7-9831-0EC6-6376FBB0D1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DA3450C-B78F-961B-DCC8-DBF4DFD59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B09CEB5-2F55-B424-7FF1-5CD41862E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9DACE28-AB0B-49BD-D801-45016786E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4373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EABB56-4463-769E-9139-F5F6CBB41E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02D4F17-0F53-BF73-F9AD-620B2ECD5A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6497B5B-5B22-27AF-BB63-4D14BADD9C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E8CC3736-A5F9-0D5B-C0A2-FC436FCDD0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B88668F-C8C7-841C-CE54-15DE20C1F3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8AA3782-5E60-9F04-E90C-91B3BDE58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1D8E16A5-CD04-F445-37CF-25CC2F05CA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209DAE7-6E28-3DE8-E5E2-5A3E8D850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2290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A7785D5-5A28-8F2C-8799-08F1998346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40AA6F1-018D-1226-D9B4-B82855763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0A3B654-0241-8B08-D05B-8CFDE1485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99F0134-EE61-4062-B2E3-282FA14D6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831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A029A30-4472-1068-AF58-9602404B2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2557C3B-A91F-8D19-7A68-1F9E56D83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9D8DA51-36D0-1008-7930-644AA9782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4020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7274CDF-1F8C-D4FD-15F3-7E06486946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7E4E6EC-F27C-2253-ED24-95DD4687BB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7A29F50-1793-85B3-725D-8B81A7D510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369BBAE-9A75-23D7-15DD-1CA0D844B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C9DEAA8-DEA8-DC3A-BF9F-0DD59699B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40C5F08-BCAB-8DDD-5E07-53A39DCD0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3137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2A98DA-B8A4-BD46-33AC-8F4A5354B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F20A09A-2C39-0C41-E89D-807F7624F0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A817AC9-8EB3-B38D-6E8F-EB820F0304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DED72F0-31D5-D595-14B6-6BCF916A4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3A90A68-033D-258E-B631-7C805532D2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B02A519-57F5-1E9D-C00F-2EE5FCA76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3994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DBB24C9-582B-B50E-C66B-501F86D73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E8D317A-5473-5E5A-8312-C3ECD3BBB0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E2ACCB9-29B7-F021-C080-87E58DE957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9627D-26F0-4EF4-A02C-B1E144E79EFE}" type="datetimeFigureOut">
              <a:rPr lang="es-ES" smtClean="0"/>
              <a:t>13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F4CBD47-1A49-91B8-D6ED-20D876DEE8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39BD12-4E29-04A7-0AA1-DF2341ACC6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BEEE6-4898-4713-A9E5-3F7F4FC06A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8536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B0161B9-8AA0-2E32-09D5-89A89F34B571}"/>
              </a:ext>
            </a:extLst>
          </p:cNvPr>
          <p:cNvSpPr txBox="1"/>
          <p:nvPr/>
        </p:nvSpPr>
        <p:spPr>
          <a:xfrm>
            <a:off x="4768090" y="13760"/>
            <a:ext cx="3263812" cy="3937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68" b="1" dirty="0">
                <a:latin typeface="Palatino Linotype" panose="02040502050505030304" pitchFamily="18" charset="0"/>
              </a:rPr>
              <a:t>Original, unedited, images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1D6CB037-7181-F494-A86E-E2943C676F36}"/>
              </a:ext>
            </a:extLst>
          </p:cNvPr>
          <p:cNvGrpSpPr/>
          <p:nvPr/>
        </p:nvGrpSpPr>
        <p:grpSpPr>
          <a:xfrm>
            <a:off x="4401646" y="496421"/>
            <a:ext cx="3747485" cy="1900782"/>
            <a:chOff x="4473287" y="448690"/>
            <a:chExt cx="3808479" cy="193171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9B13B97-7C25-08E8-3F8E-BEA37CEFFEE4}"/>
                </a:ext>
              </a:extLst>
            </p:cNvPr>
            <p:cNvSpPr txBox="1"/>
            <p:nvPr/>
          </p:nvSpPr>
          <p:spPr>
            <a:xfrm>
              <a:off x="4473287" y="448690"/>
              <a:ext cx="25523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78" b="1" dirty="0">
                  <a:latin typeface="Palatino Linotype" panose="02040502050505030304" pitchFamily="18" charset="0"/>
                </a:rPr>
                <a:t>2.  A</a:t>
              </a:r>
              <a:r>
                <a:rPr lang="el-GR" sz="1378" b="1" dirty="0">
                  <a:latin typeface="Palatino Linotype" panose="02040502050505030304" pitchFamily="18" charset="0"/>
                  <a:cs typeface="Calibri" panose="020F0502020204030204" pitchFamily="34" charset="0"/>
                </a:rPr>
                <a:t>β</a:t>
              </a:r>
              <a:r>
                <a:rPr lang="en-US" sz="1378" b="1" dirty="0">
                  <a:latin typeface="Palatino Linotype" panose="02040502050505030304" pitchFamily="18" charset="0"/>
                  <a:cs typeface="Calibri" panose="020F0502020204030204" pitchFamily="34" charset="0"/>
                </a:rPr>
                <a:t>1-42 dot blot (for Fig. 3)</a:t>
              </a:r>
              <a:endParaRPr lang="en-US" sz="1378" b="1" dirty="0">
                <a:latin typeface="Palatino Linotype" panose="02040502050505030304" pitchFamily="18" charset="0"/>
              </a:endParaRPr>
            </a:p>
          </p:txBody>
        </p:sp>
        <p:pic>
          <p:nvPicPr>
            <p:cNvPr id="8" name="Picture 7" descr="Chart, bubble chart&#10;&#10;Description automatically generated">
              <a:extLst>
                <a:ext uri="{FF2B5EF4-FFF2-40B4-BE49-F238E27FC236}">
                  <a16:creationId xmlns:a16="http://schemas.microsoft.com/office/drawing/2014/main" id="{F7C33978-2BA0-F326-6BD4-45C1BDEE1E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407" r="11316" b="21949"/>
            <a:stretch/>
          </p:blipFill>
          <p:spPr>
            <a:xfrm>
              <a:off x="4473287" y="747551"/>
              <a:ext cx="3808479" cy="1632858"/>
            </a:xfrm>
            <a:prstGeom prst="rect">
              <a:avLst/>
            </a:prstGeom>
          </p:spPr>
        </p:pic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2EFB4E38-0493-E782-0293-28EADB3F1D8F}"/>
              </a:ext>
            </a:extLst>
          </p:cNvPr>
          <p:cNvGrpSpPr/>
          <p:nvPr/>
        </p:nvGrpSpPr>
        <p:grpSpPr>
          <a:xfrm>
            <a:off x="197744" y="496421"/>
            <a:ext cx="3819371" cy="1900782"/>
            <a:chOff x="200962" y="448690"/>
            <a:chExt cx="3881535" cy="1931719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A5C5E86-DF3F-A3C3-03F0-D90485534636}"/>
                </a:ext>
              </a:extLst>
            </p:cNvPr>
            <p:cNvSpPr txBox="1"/>
            <p:nvPr/>
          </p:nvSpPr>
          <p:spPr>
            <a:xfrm>
              <a:off x="200962" y="448690"/>
              <a:ext cx="25138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78" b="1" dirty="0">
                  <a:latin typeface="Palatino Linotype" panose="02040502050505030304" pitchFamily="18" charset="0"/>
                </a:rPr>
                <a:t>1.  Ponceau stain (for Fig. 3)  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72F4D17-2F1E-5899-788C-4B59BC121D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6786" t="43673" r="41378" b="32517"/>
            <a:stretch/>
          </p:blipFill>
          <p:spPr>
            <a:xfrm>
              <a:off x="200962" y="747551"/>
              <a:ext cx="3881535" cy="1632858"/>
            </a:xfrm>
            <a:prstGeom prst="rect">
              <a:avLst/>
            </a:prstGeom>
          </p:spPr>
        </p:pic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1F0A81AB-073B-F02E-4607-E05D1CAA4898}"/>
              </a:ext>
            </a:extLst>
          </p:cNvPr>
          <p:cNvSpPr txBox="1"/>
          <p:nvPr/>
        </p:nvSpPr>
        <p:spPr>
          <a:xfrm>
            <a:off x="5092660" y="2966026"/>
            <a:ext cx="2006680" cy="25893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82" u="sng" dirty="0">
                <a:latin typeface="Palatino Linotype" panose="02040502050505030304" pitchFamily="18" charset="0"/>
              </a:rPr>
              <a:t>Lanes</a:t>
            </a:r>
            <a:r>
              <a:rPr lang="en-US" sz="1082" dirty="0">
                <a:latin typeface="Palatino Linotype" panose="02040502050505030304" pitchFamily="18" charset="0"/>
              </a:rPr>
              <a:t>:</a:t>
            </a:r>
          </a:p>
          <a:p>
            <a:pPr marL="224942" indent="-224942">
              <a:buAutoNum type="arabicPeriod"/>
            </a:pPr>
            <a:r>
              <a:rPr lang="en-US" sz="1082" dirty="0">
                <a:latin typeface="Palatino Linotype" panose="02040502050505030304" pitchFamily="18" charset="0"/>
              </a:rPr>
              <a:t>Molecular weight marker</a:t>
            </a:r>
          </a:p>
          <a:p>
            <a:pPr marL="224942" indent="-224942">
              <a:buAutoNum type="arabicPeriod"/>
            </a:pPr>
            <a:r>
              <a:rPr lang="en-US" sz="1082" dirty="0">
                <a:latin typeface="Palatino Linotype" panose="02040502050505030304" pitchFamily="18" charset="0"/>
              </a:rPr>
              <a:t>Vehicle (saline) – WT </a:t>
            </a:r>
          </a:p>
          <a:p>
            <a:pPr marL="224942" indent="-224942">
              <a:buAutoNum type="arabicPeriod"/>
            </a:pPr>
            <a:r>
              <a:rPr lang="en-US" sz="1082" dirty="0" err="1">
                <a:latin typeface="Palatino Linotype" panose="02040502050505030304" pitchFamily="18" charset="0"/>
              </a:rPr>
              <a:t>Nosustrophine</a:t>
            </a:r>
            <a:r>
              <a:rPr lang="en-US" sz="1082" dirty="0">
                <a:latin typeface="Palatino Linotype" panose="02040502050505030304" pitchFamily="18" charset="0"/>
              </a:rPr>
              <a:t> - WT</a:t>
            </a:r>
          </a:p>
          <a:p>
            <a:pPr marL="224942" indent="-224942">
              <a:buAutoNum type="arabicPeriod"/>
            </a:pPr>
            <a:r>
              <a:rPr lang="en-US" sz="1082" dirty="0">
                <a:latin typeface="Palatino Linotype" panose="02040502050505030304" pitchFamily="18" charset="0"/>
              </a:rPr>
              <a:t>Vehicle - WT</a:t>
            </a:r>
          </a:p>
          <a:p>
            <a:pPr marL="224942" indent="-224942">
              <a:buAutoNum type="arabicPeriod"/>
            </a:pPr>
            <a:r>
              <a:rPr lang="en-US" sz="1082" dirty="0">
                <a:latin typeface="Palatino Linotype" panose="02040502050505030304" pitchFamily="18" charset="0"/>
              </a:rPr>
              <a:t>Vehicle – 3xTg-AD</a:t>
            </a:r>
          </a:p>
          <a:p>
            <a:pPr marL="224942" indent="-224942">
              <a:buAutoNum type="arabicPeriod"/>
            </a:pPr>
            <a:r>
              <a:rPr lang="en-US" sz="1082" dirty="0">
                <a:latin typeface="Palatino Linotype" panose="02040502050505030304" pitchFamily="18" charset="0"/>
              </a:rPr>
              <a:t>Vehicle – 3xTg-AD</a:t>
            </a:r>
          </a:p>
          <a:p>
            <a:pPr marL="224942" indent="-224942">
              <a:buFontTx/>
              <a:buAutoNum type="arabicPeriod"/>
            </a:pPr>
            <a:r>
              <a:rPr lang="en-US" sz="1082" dirty="0">
                <a:latin typeface="Palatino Linotype" panose="02040502050505030304" pitchFamily="18" charset="0"/>
              </a:rPr>
              <a:t>Vehicle – 3xTg-AD</a:t>
            </a:r>
          </a:p>
          <a:p>
            <a:pPr marL="224942" indent="-224942">
              <a:buFontTx/>
              <a:buAutoNum type="arabicPeriod"/>
            </a:pPr>
            <a:r>
              <a:rPr lang="en-US" sz="1082" dirty="0" err="1">
                <a:latin typeface="Palatino Linotype" panose="02040502050505030304" pitchFamily="18" charset="0"/>
              </a:rPr>
              <a:t>Nosustrophine</a:t>
            </a:r>
            <a:r>
              <a:rPr lang="en-US" sz="1082" dirty="0">
                <a:latin typeface="Palatino Linotype" panose="02040502050505030304" pitchFamily="18" charset="0"/>
              </a:rPr>
              <a:t> – WT</a:t>
            </a:r>
          </a:p>
          <a:p>
            <a:pPr marL="224942" indent="-224942">
              <a:buFontTx/>
              <a:buAutoNum type="arabicPeriod"/>
            </a:pPr>
            <a:r>
              <a:rPr lang="en-US" sz="1082" dirty="0" err="1">
                <a:latin typeface="Palatino Linotype" panose="02040502050505030304" pitchFamily="18" charset="0"/>
              </a:rPr>
              <a:t>Nosustrophine</a:t>
            </a:r>
            <a:r>
              <a:rPr lang="en-US" sz="1082" dirty="0">
                <a:latin typeface="Palatino Linotype" panose="02040502050505030304" pitchFamily="18" charset="0"/>
              </a:rPr>
              <a:t> - 3xTg-AD</a:t>
            </a:r>
          </a:p>
          <a:p>
            <a:pPr marL="224942" indent="-224942">
              <a:buFontTx/>
              <a:buAutoNum type="arabicPeriod"/>
            </a:pPr>
            <a:r>
              <a:rPr lang="en-US" sz="1082" dirty="0" err="1">
                <a:latin typeface="Palatino Linotype" panose="02040502050505030304" pitchFamily="18" charset="0"/>
              </a:rPr>
              <a:t>Nosustrophine</a:t>
            </a:r>
            <a:r>
              <a:rPr lang="en-US" sz="1082" dirty="0">
                <a:latin typeface="Palatino Linotype" panose="02040502050505030304" pitchFamily="18" charset="0"/>
              </a:rPr>
              <a:t> - 3xTg-AD</a:t>
            </a:r>
          </a:p>
          <a:p>
            <a:pPr marL="224942" indent="-224942">
              <a:buFontTx/>
              <a:buAutoNum type="arabicPeriod"/>
            </a:pPr>
            <a:r>
              <a:rPr lang="en-US" sz="1082" dirty="0" err="1">
                <a:latin typeface="Palatino Linotype" panose="02040502050505030304" pitchFamily="18" charset="0"/>
              </a:rPr>
              <a:t>Nosustrophine</a:t>
            </a:r>
            <a:r>
              <a:rPr lang="en-US" sz="1082" dirty="0">
                <a:latin typeface="Palatino Linotype" panose="02040502050505030304" pitchFamily="18" charset="0"/>
              </a:rPr>
              <a:t> - 3xTg-AD</a:t>
            </a:r>
          </a:p>
          <a:p>
            <a:pPr marL="224942" indent="-224942">
              <a:buFontTx/>
              <a:buAutoNum type="arabicPeriod"/>
            </a:pPr>
            <a:r>
              <a:rPr lang="en-US" sz="1082" dirty="0">
                <a:latin typeface="Palatino Linotype" panose="02040502050505030304" pitchFamily="18" charset="0"/>
              </a:rPr>
              <a:t>Molecular weight marker</a:t>
            </a:r>
          </a:p>
          <a:p>
            <a:endParaRPr lang="en-US" sz="1082" dirty="0">
              <a:latin typeface="Palatino Linotype" panose="02040502050505030304" pitchFamily="18" charset="0"/>
            </a:endParaRPr>
          </a:p>
          <a:p>
            <a:r>
              <a:rPr lang="en-US" sz="1082" i="1" dirty="0">
                <a:latin typeface="Palatino Linotype" panose="02040502050505030304" pitchFamily="18" charset="0"/>
              </a:rPr>
              <a:t>WT, wild-type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65C7034D-6C3C-BFE9-143D-E8600C8854E5}"/>
              </a:ext>
            </a:extLst>
          </p:cNvPr>
          <p:cNvGrpSpPr/>
          <p:nvPr/>
        </p:nvGrpSpPr>
        <p:grpSpPr>
          <a:xfrm>
            <a:off x="175972" y="2740600"/>
            <a:ext cx="4831539" cy="3909568"/>
            <a:chOff x="178836" y="2729396"/>
            <a:chExt cx="4910177" cy="397320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CDB1C73-9333-F4BD-6F1F-A94D5E2A0AC1}"/>
                </a:ext>
              </a:extLst>
            </p:cNvPr>
            <p:cNvSpPr txBox="1"/>
            <p:nvPr/>
          </p:nvSpPr>
          <p:spPr>
            <a:xfrm>
              <a:off x="178836" y="2729396"/>
              <a:ext cx="44048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78" b="1" dirty="0">
                  <a:latin typeface="Palatino Linotype" panose="02040502050505030304" pitchFamily="18" charset="0"/>
                </a:rPr>
                <a:t>3.  Western blot (acetylated-histone H3) (for Fig. 10) 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FAE08D5C-88CF-F617-012F-3E1908589EB5}"/>
                </a:ext>
              </a:extLst>
            </p:cNvPr>
            <p:cNvGrpSpPr/>
            <p:nvPr/>
          </p:nvGrpSpPr>
          <p:grpSpPr>
            <a:xfrm>
              <a:off x="178836" y="3044996"/>
              <a:ext cx="4294451" cy="3657600"/>
              <a:chOff x="178836" y="3044996"/>
              <a:chExt cx="4294451" cy="3657600"/>
            </a:xfrm>
          </p:grpSpPr>
          <p:pic>
            <p:nvPicPr>
              <p:cNvPr id="11" name="Picture 10" descr="A picture containing shape&#10;&#10;Description automatically generated">
                <a:extLst>
                  <a:ext uri="{FF2B5EF4-FFF2-40B4-BE49-F238E27FC236}">
                    <a16:creationId xmlns:a16="http://schemas.microsoft.com/office/drawing/2014/main" id="{502606F6-42DC-9A62-269D-2360C00A79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78836" y="3044996"/>
                <a:ext cx="4294451" cy="3657600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DB8FC04-CBD2-E3F2-7311-9EB3D8A14FC6}"/>
                  </a:ext>
                </a:extLst>
              </p:cNvPr>
              <p:cNvSpPr txBox="1"/>
              <p:nvPr/>
            </p:nvSpPr>
            <p:spPr>
              <a:xfrm>
                <a:off x="876212" y="4379034"/>
                <a:ext cx="323838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78" dirty="0"/>
                  <a:t>1    2    3    4     5     6    7    8    9   10   11  12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3ECA1003-7093-7C98-0583-BFDA70706C13}"/>
                </a:ext>
              </a:extLst>
            </p:cNvPr>
            <p:cNvGrpSpPr/>
            <p:nvPr/>
          </p:nvGrpSpPr>
          <p:grpSpPr>
            <a:xfrm>
              <a:off x="4232126" y="4686811"/>
              <a:ext cx="856887" cy="261610"/>
              <a:chOff x="4232126" y="4686811"/>
              <a:chExt cx="856887" cy="261610"/>
            </a:xfrm>
          </p:grpSpPr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id="{C7DCCEF9-5F29-76F8-6720-A9D929A7772F}"/>
                  </a:ext>
                </a:extLst>
              </p:cNvPr>
              <p:cNvCxnSpPr/>
              <p:nvPr/>
            </p:nvCxnSpPr>
            <p:spPr>
              <a:xfrm flipH="1">
                <a:off x="4232126" y="4801065"/>
                <a:ext cx="28963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AE13352-F75B-5E59-1C41-FDC6A1D3F210}"/>
                  </a:ext>
                </a:extLst>
              </p:cNvPr>
              <p:cNvSpPr txBox="1"/>
              <p:nvPr/>
            </p:nvSpPr>
            <p:spPr>
              <a:xfrm>
                <a:off x="4434667" y="4686811"/>
                <a:ext cx="6543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82" dirty="0">
                    <a:latin typeface="Palatino Linotype" panose="02040502050505030304" pitchFamily="18" charset="0"/>
                  </a:rPr>
                  <a:t> 17 </a:t>
                </a:r>
                <a:r>
                  <a:rPr lang="en-US" sz="1082" dirty="0" err="1">
                    <a:latin typeface="Palatino Linotype" panose="02040502050505030304" pitchFamily="18" charset="0"/>
                  </a:rPr>
                  <a:t>kDa</a:t>
                </a:r>
                <a:endParaRPr lang="en-US" sz="1082" dirty="0">
                  <a:latin typeface="Palatino Linotype" panose="02040502050505030304" pitchFamily="18" charset="0"/>
                </a:endParaRPr>
              </a:p>
            </p:txBody>
          </p:sp>
        </p:grp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F2774049-1390-DCD1-5615-114FDCD340F9}"/>
              </a:ext>
            </a:extLst>
          </p:cNvPr>
          <p:cNvGrpSpPr/>
          <p:nvPr/>
        </p:nvGrpSpPr>
        <p:grpSpPr>
          <a:xfrm>
            <a:off x="7392255" y="2739397"/>
            <a:ext cx="4469154" cy="3903073"/>
            <a:chOff x="7512572" y="2728173"/>
            <a:chExt cx="4541894" cy="3966600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C57295ED-7417-FF06-B208-A5E024DBC2B5}"/>
                </a:ext>
              </a:extLst>
            </p:cNvPr>
            <p:cNvGrpSpPr/>
            <p:nvPr/>
          </p:nvGrpSpPr>
          <p:grpSpPr>
            <a:xfrm>
              <a:off x="7512572" y="3037173"/>
              <a:ext cx="4294451" cy="3657600"/>
              <a:chOff x="6568027" y="3035471"/>
              <a:chExt cx="4294451" cy="3657600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F8D32269-6327-2523-62B6-45A16732B5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568027" y="3035471"/>
                <a:ext cx="4294451" cy="3657600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CDDD8A7-EA1A-D6A9-BEB6-F3E251183897}"/>
                  </a:ext>
                </a:extLst>
              </p:cNvPr>
              <p:cNvSpPr txBox="1"/>
              <p:nvPr/>
            </p:nvSpPr>
            <p:spPr>
              <a:xfrm>
                <a:off x="7186647" y="4170840"/>
                <a:ext cx="323838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78" dirty="0"/>
                  <a:t>1    2    3    4     5     6    7    8    9   10   11  12</a:t>
                </a:r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DBEA79D-FC61-DF62-85E9-CBA6F245282E}"/>
                </a:ext>
              </a:extLst>
            </p:cNvPr>
            <p:cNvSpPr txBox="1"/>
            <p:nvPr/>
          </p:nvSpPr>
          <p:spPr>
            <a:xfrm>
              <a:off x="7512572" y="2728173"/>
              <a:ext cx="38870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78" b="1" dirty="0">
                  <a:latin typeface="Palatino Linotype" panose="02040502050505030304" pitchFamily="18" charset="0"/>
                </a:rPr>
                <a:t>4.  Western blot (total histone H3) (for Fig. 10)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2D683AFD-8C1D-146F-34F8-140846A03B86}"/>
                </a:ext>
              </a:extLst>
            </p:cNvPr>
            <p:cNvGrpSpPr/>
            <p:nvPr/>
          </p:nvGrpSpPr>
          <p:grpSpPr>
            <a:xfrm>
              <a:off x="11187531" y="4688710"/>
              <a:ext cx="866935" cy="261610"/>
              <a:chOff x="4171838" y="4666715"/>
              <a:chExt cx="866935" cy="261610"/>
            </a:xfrm>
          </p:grpSpPr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54595566-43EE-948E-20AA-0BB1A2C15C54}"/>
                  </a:ext>
                </a:extLst>
              </p:cNvPr>
              <p:cNvCxnSpPr/>
              <p:nvPr/>
            </p:nvCxnSpPr>
            <p:spPr>
              <a:xfrm flipH="1">
                <a:off x="4171838" y="4791017"/>
                <a:ext cx="28963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48BC497-B18C-DF61-D064-90A6DC47B49A}"/>
                  </a:ext>
                </a:extLst>
              </p:cNvPr>
              <p:cNvSpPr txBox="1"/>
              <p:nvPr/>
            </p:nvSpPr>
            <p:spPr>
              <a:xfrm>
                <a:off x="4384427" y="4666715"/>
                <a:ext cx="6543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82" dirty="0">
                    <a:latin typeface="Palatino Linotype" panose="02040502050505030304" pitchFamily="18" charset="0"/>
                  </a:rPr>
                  <a:t> 17 </a:t>
                </a:r>
                <a:r>
                  <a:rPr lang="en-US" sz="1082" dirty="0" err="1">
                    <a:latin typeface="Palatino Linotype" panose="02040502050505030304" pitchFamily="18" charset="0"/>
                  </a:rPr>
                  <a:t>kDa</a:t>
                </a:r>
                <a:endParaRPr lang="en-US" sz="1082" dirty="0">
                  <a:latin typeface="Palatino Linotype" panose="0204050205050503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602482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Panorámica</PresentationFormat>
  <Paragraphs>2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pigenetica</dc:creator>
  <cp:lastModifiedBy>Epigenetica</cp:lastModifiedBy>
  <cp:revision>1</cp:revision>
  <dcterms:created xsi:type="dcterms:W3CDTF">2022-10-13T07:14:26Z</dcterms:created>
  <dcterms:modified xsi:type="dcterms:W3CDTF">2022-10-13T07:14:42Z</dcterms:modified>
</cp:coreProperties>
</file>